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50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28" autoAdjust="0"/>
    <p:restoredTop sz="81013"/>
  </p:normalViewPr>
  <p:slideViewPr>
    <p:cSldViewPr snapToGrid="0">
      <p:cViewPr varScale="1">
        <p:scale>
          <a:sx n="87" d="100"/>
          <a:sy n="87" d="100"/>
        </p:scale>
        <p:origin x="1512" y="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0E1240-FD12-C148-8DB5-B8E39C3AF3B4}" type="datetimeFigureOut">
              <a:rPr lang="en-US" smtClean="0"/>
              <a:t>5/2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494A11-E2F1-EC45-8840-D798CB12B5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6285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ppendix H Resource Assignment Orientation Slide</a:t>
            </a:r>
          </a:p>
          <a:p>
            <a:endParaRPr lang="en-US" dirty="0"/>
          </a:p>
          <a:p>
            <a:r>
              <a:rPr lang="en-US" dirty="0"/>
              <a:t>Instructions for Use: Slide should be presented by Clerkship Director or other member of Clerkship team during an orientation session for the third-year medical students at the start of their Pediatric Clerkship. Presentation of material should take 1-2 minutes.</a:t>
            </a:r>
          </a:p>
          <a:p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lease substitute whatever online learning platform your students use into the brackets (e.g. our online learning platform is Moodle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alking points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- Acknowledge that one of the reasons identifying and screening for SDH is important is that it allows us the opportunity to provide resources which can help mitigate those social determinan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- Reference handouts on SDH Resource Assignment and accompanying example form which uses WIC as a model for form comple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- Instruct students to select a resource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- Instruct students to prepare to turn in form and present information on their resource name and description, what categories of SDH this resource targets, and how the resource could benefit a pediatric patient in mitigating SDH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494A11-E2F1-EC45-8840-D798CB12B5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6493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350916-608E-4881-AA49-904089AE88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D018C6D-8C46-415D-ABA8-C1AFCE903F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19EDD2-9471-4004-A3AA-39FEF7CCC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C83D30-88D3-4C6A-866F-FDD94A384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1E2023-EBCB-4D4D-A146-800759890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241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A8412-0897-4EAC-8ECE-7A9174D3CF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3CBD7E-1122-4567-A9F4-C40B7B1751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95D4A4-6C14-4C61-96F8-FEEA5C149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653840-7C60-4DC8-861C-080F4E33F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10223B-A6C4-4687-BFF2-DE87B94F4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699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D3F2E5-247F-4B17-8AC8-A39CE3E27F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794FA9-2038-4D60-9C26-F6C5C06A5E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044B7F-A616-48A3-B8A7-ABE54955F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41A612-F0E5-4C00-A065-65C0A466E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20077F-F7D5-456B-84C6-E6142326B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113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9D370B-1015-4D3F-8295-FDE46EA82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0DD985-561B-45DF-836D-337AD2A98E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F55E8C-A887-4D99-93AD-DC9944FD9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DD045E-56B7-456C-8369-9CB00E417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538A73-EA5B-4954-894C-EC9188019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729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4AC439-87FF-4CBE-ADF1-1FD027449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1CF4A5-EA28-4BE5-BEF1-589DA12D95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445973-773A-462E-B3DD-1E51134E6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CB3E8-A7DA-4307-9937-9C1A813D3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A75AB-2991-4E42-BDB8-AF21B7854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996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88BAA4-DAE2-4820-9CC8-BF400048AE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EA18A8-0C99-499C-99A2-070DB3A8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4C361F-CE80-4F06-862F-66948B876F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8A510E-4AD4-47E3-8A3F-A89B86ADC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B34C12-8939-4477-9B43-73F13AD60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FDAC3A-8060-4068-A05B-8DDD4DF62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623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1E56A8-AC11-4152-A885-BD296DA3C0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C5E491-FEE1-4C28-BA33-115E30C71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8E36EF-626E-492C-A207-211ED94150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CAC750-0D35-4919-A1EA-20F9269EC1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0111A2B-CF38-44EF-81AB-6DD0E7CEF7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A7C1DB-2CE5-4CE0-8848-7EB338565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987AA8-B5F5-4410-AD08-0674716DD1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6064BAF-BE9E-4C21-BB79-4B4DAA212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651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9A536D-2937-4FC6-8052-263544707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F4C4F4-FE46-43A2-8E8A-6E4188876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8DB2DE-A8CD-43FA-9399-D56829210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BBE047-20DB-4886-BC20-7C2E48EEC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175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15A15CA-B097-4F85-BE02-816CCDC2A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94F3E5-23C7-4B38-AB12-9D737C734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5F7C54-4D3A-4D9C-BF3F-DD179A6BF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9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9F9223-01E3-4A4C-A678-0262A0C77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870951-A150-440E-8349-BCD05E0060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7B405A-8D38-4AF7-B13D-4FAFF8AC7B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473C8B-6021-431F-9D1F-0ABF01E03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59D63A-7F86-46C5-ABEC-E64BB8731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6AA8C2-966B-4332-A784-DDB8350054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028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C8323-5D4D-41E3-A8CF-AC1FC4E8E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198E92-32D5-402F-B3C6-0A4695FFAC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1E9E70-A532-48F1-898F-1B9B52B2E8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48410D-B042-4010-A663-BBDA3D779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63DCCD-1618-4CA2-9639-800A17873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531423-8920-44F9-9D3B-AFFE15BA7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091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BC3EFD-6B71-4637-880A-F3D013C45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B53E8E-E240-4B73-8BA1-48A2C15D7C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652AE5-B1ED-4167-BA76-1D06DE4B52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B6EB3-E465-4CAF-B9AF-4C390140F3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8C7DC4-2D2C-46DE-B503-7B642DBC37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265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Resource Assignment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>
          <a:xfrm>
            <a:off x="2019300" y="1905000"/>
            <a:ext cx="8153400" cy="4495800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SDH Resource Assignment Form and an example are in your orientation packet and on [your online learning platform]</a:t>
            </a:r>
          </a:p>
          <a:p>
            <a:r>
              <a:rPr lang="en-US" dirty="0"/>
              <a:t>Please choose a resource from the Assignment Form or a resource of your own choosing that could help mitigate social determinants of health for a pediatric patient</a:t>
            </a:r>
          </a:p>
          <a:p>
            <a:r>
              <a:rPr lang="en-US" dirty="0"/>
              <a:t>At your Chronic Illness Small Group please be prepared to briefly present and turn in the following information:</a:t>
            </a:r>
          </a:p>
          <a:p>
            <a:pPr lvl="1"/>
            <a:r>
              <a:rPr lang="en-US" dirty="0"/>
              <a:t>Name and description of resource</a:t>
            </a:r>
          </a:p>
          <a:p>
            <a:pPr lvl="1"/>
            <a:r>
              <a:rPr lang="en-US" dirty="0"/>
              <a:t>Category/Categories of SDH this resource addresses </a:t>
            </a:r>
          </a:p>
          <a:p>
            <a:pPr lvl="1"/>
            <a:r>
              <a:rPr lang="en-US" dirty="0"/>
              <a:t>Explanation of how this resource could benefit a pediatric patient</a:t>
            </a:r>
          </a:p>
          <a:p>
            <a:pPr>
              <a:buNone/>
            </a:pPr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130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264</Words>
  <Application>Microsoft Macintosh PowerPoint</Application>
  <PresentationFormat>Widescreen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Resource Assignme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udhomme, Amy V.</dc:creator>
  <cp:lastModifiedBy>Roth, Caroline M.</cp:lastModifiedBy>
  <cp:revision>9</cp:revision>
  <dcterms:created xsi:type="dcterms:W3CDTF">2021-03-26T15:10:02Z</dcterms:created>
  <dcterms:modified xsi:type="dcterms:W3CDTF">2024-05-28T16:33:30Z</dcterms:modified>
</cp:coreProperties>
</file>